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F5AB1C69-6EDB-4FF4-983F-18BD219EF322}" styleName="Stile medio 2 - Colore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14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DC325CFB-6523-48D7-A9C3-93AE0496BE6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FC751C00-DF6F-47C9-A844-C13C0A3F8DF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7E642DEB-E0D3-4CA4-935A-C4FEB3739E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081EC3-759F-40AB-896D-E38606825668}" type="datetimeFigureOut">
              <a:rPr lang="it-IT" smtClean="0"/>
              <a:t>12/02/2026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28A5FD2A-07DD-4AB5-8140-69BD65F42C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D9C83CC2-3E5F-4698-814E-48EF360E8E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82C5A7-83F0-4F57-88F9-C3C538EFA28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980620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9B01FE4-255A-4033-896D-DED725776EA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6AD516FC-5096-441E-8A4E-54687F4AB0A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5D4580EE-FB1A-47C4-9D12-15A0C7956A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081EC3-759F-40AB-896D-E38606825668}" type="datetimeFigureOut">
              <a:rPr lang="it-IT" smtClean="0"/>
              <a:t>12/02/2026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C4F5A096-9B58-401D-9EAE-E3EC1BDCDD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46233E82-6F7F-4CC1-8BC0-8494EAEF40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82C5A7-83F0-4F57-88F9-C3C538EFA28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819377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D89B19B9-1E7A-473C-BBB8-737853FD15B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01FDF380-6EE7-49B5-9119-AFE9B81E888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5E3DFA16-4267-48F0-A720-E39670EC13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081EC3-759F-40AB-896D-E38606825668}" type="datetimeFigureOut">
              <a:rPr lang="it-IT" smtClean="0"/>
              <a:t>12/02/2026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C1404D29-24F5-4323-AE90-2CB0DB5D7D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8B83B6AA-6470-429C-A035-5FB7CE4ED2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82C5A7-83F0-4F57-88F9-C3C538EFA28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382875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3D3A43B0-BBAA-422F-B600-9365DA8F477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7F790876-6032-4107-859B-7A217BEE647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6384A816-73F8-4DE0-B9A2-D78F9FD3FE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081EC3-759F-40AB-896D-E38606825668}" type="datetimeFigureOut">
              <a:rPr lang="it-IT" smtClean="0"/>
              <a:t>12/02/2026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FF9A7D7D-DDBA-44DF-BE24-483AED226D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800920F2-E34C-496B-94E9-2DDCBB8B90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82C5A7-83F0-4F57-88F9-C3C538EFA28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333478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B5064246-D1FE-4A0B-BC41-0980E226ADE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FE6F7E81-3D78-48CC-97CD-7EDAD42F416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B50D5EC6-0DD5-4B04-9642-7A067C5D03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081EC3-759F-40AB-896D-E38606825668}" type="datetimeFigureOut">
              <a:rPr lang="it-IT" smtClean="0"/>
              <a:t>12/02/2026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63DCB611-504C-4410-ADB7-15EFDDA622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0A075530-6A04-439F-8D7B-0262C11186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82C5A7-83F0-4F57-88F9-C3C538EFA28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593862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DC792D8-C0C8-4981-B4D7-04139C9A3B1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21622670-CBD6-4163-A238-18A67C498AE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7EC291D9-D928-4F4A-94D9-05D592DA2DC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2F799607-B6A6-48D6-9D15-381B215E7D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081EC3-759F-40AB-896D-E38606825668}" type="datetimeFigureOut">
              <a:rPr lang="it-IT" smtClean="0"/>
              <a:t>12/02/2026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48AEB508-48D9-4640-8B9C-32898E3629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FD90D065-B684-46F2-9F57-7A2FF7790C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82C5A7-83F0-4F57-88F9-C3C538EFA28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158394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190A69FC-21E7-40BF-9C5C-869F3275330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7D4385F8-8780-4616-A945-FBD11062742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6B269A89-A74F-49C1-BB71-A02CCA51E02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F063F757-E057-4B67-B88D-42A529E87BB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CFE0DFC6-5446-4C45-879D-7289A88487A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1FA306F1-02B4-489A-9C9A-87836F2504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081EC3-759F-40AB-896D-E38606825668}" type="datetimeFigureOut">
              <a:rPr lang="it-IT" smtClean="0"/>
              <a:t>12/02/2026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D4C2E361-9A96-478F-B888-3A986D82B7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866A53B8-71FA-423D-B7BE-F4431C5099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82C5A7-83F0-4F57-88F9-C3C538EFA28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477761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7D24AE2C-157F-430D-A642-2D1C1645928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4BF97F45-40FB-4B9E-BC08-970F4EFD1C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081EC3-759F-40AB-896D-E38606825668}" type="datetimeFigureOut">
              <a:rPr lang="it-IT" smtClean="0"/>
              <a:t>12/02/2026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C7F1018A-10EA-4747-88EE-15B9C45ACD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6372487A-0AE7-49D1-A35F-70A8687460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82C5A7-83F0-4F57-88F9-C3C538EFA28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5255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961E8C5F-2DD3-4CA4-BFD7-55D1BD9E25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081EC3-759F-40AB-896D-E38606825668}" type="datetimeFigureOut">
              <a:rPr lang="it-IT" smtClean="0"/>
              <a:t>12/02/2026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842D323A-DD71-4884-AF2F-C548E114B0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29E81AC7-1CD1-46F1-A6A5-711561815D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82C5A7-83F0-4F57-88F9-C3C538EFA28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022632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91F3680-B779-4684-B3B4-58AB340A1EB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392835A3-8B5B-4D51-B0A6-E566AF5B35F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FC1EAAD5-10C7-4DE6-A69A-0B3EAAF45C8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DF72B992-2FD5-45D0-B51D-1E108D94FD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081EC3-759F-40AB-896D-E38606825668}" type="datetimeFigureOut">
              <a:rPr lang="it-IT" smtClean="0"/>
              <a:t>12/02/2026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DE473808-763A-4D7D-854D-3E7945077B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5829F3AA-3314-4894-BC01-212CDAB23F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82C5A7-83F0-4F57-88F9-C3C538EFA28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947951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9658800D-0033-4E6D-8D32-0902DB3B61F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0953D69E-B68A-4D06-B6AB-E9E575A463F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4D4B9FE3-A9FD-4B16-836C-73B565B1290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B356B2D8-0D4B-4DA1-BFEE-C528EF53BB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081EC3-759F-40AB-896D-E38606825668}" type="datetimeFigureOut">
              <a:rPr lang="it-IT" smtClean="0"/>
              <a:t>12/02/2026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7AAF6798-D80B-4FBC-B027-55E139C6E3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8F4B8CAB-C31A-4DE6-803B-A84220A1F3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82C5A7-83F0-4F57-88F9-C3C538EFA28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551243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8E97391F-BD68-4AAC-84AB-29556C90DB9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442DA805-FDE6-4D14-AC7C-64A28FAB358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2FA13C1F-A1D7-4B51-AD5A-12D73545DD5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081EC3-759F-40AB-896D-E38606825668}" type="datetimeFigureOut">
              <a:rPr lang="it-IT" smtClean="0"/>
              <a:t>12/02/2026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4D088AAB-6C54-4655-B2CA-A1E85146AEB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CC7EFB95-DA6F-44BE-BBA4-4DB78C074BC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82C5A7-83F0-4F57-88F9-C3C538EFA28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935697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ella 3">
            <a:extLst>
              <a:ext uri="{FF2B5EF4-FFF2-40B4-BE49-F238E27FC236}">
                <a16:creationId xmlns:a16="http://schemas.microsoft.com/office/drawing/2014/main" id="{60890811-8355-44EB-BCE4-BEC7D4ADF04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40540816"/>
              </p:ext>
            </p:extLst>
          </p:nvPr>
        </p:nvGraphicFramePr>
        <p:xfrm>
          <a:off x="2444499" y="1650815"/>
          <a:ext cx="6396990" cy="4180840"/>
        </p:xfrm>
        <a:graphic>
          <a:graphicData uri="http://schemas.openxmlformats.org/drawingml/2006/table">
            <a:tbl>
              <a:tblPr firstRow="1" firstCol="1" bandRow="1">
                <a:tableStyleId>{F5AB1C69-6EDB-4FF4-983F-18BD219EF322}</a:tableStyleId>
              </a:tblPr>
              <a:tblGrid>
                <a:gridCol w="961431">
                  <a:extLst>
                    <a:ext uri="{9D8B030D-6E8A-4147-A177-3AD203B41FA5}">
                      <a16:colId xmlns:a16="http://schemas.microsoft.com/office/drawing/2014/main" val="696257251"/>
                    </a:ext>
                  </a:extLst>
                </a:gridCol>
                <a:gridCol w="469783">
                  <a:extLst>
                    <a:ext uri="{9D8B030D-6E8A-4147-A177-3AD203B41FA5}">
                      <a16:colId xmlns:a16="http://schemas.microsoft.com/office/drawing/2014/main" val="164917795"/>
                    </a:ext>
                  </a:extLst>
                </a:gridCol>
                <a:gridCol w="730961">
                  <a:extLst>
                    <a:ext uri="{9D8B030D-6E8A-4147-A177-3AD203B41FA5}">
                      <a16:colId xmlns:a16="http://schemas.microsoft.com/office/drawing/2014/main" val="41445442"/>
                    </a:ext>
                  </a:extLst>
                </a:gridCol>
                <a:gridCol w="669290">
                  <a:extLst>
                    <a:ext uri="{9D8B030D-6E8A-4147-A177-3AD203B41FA5}">
                      <a16:colId xmlns:a16="http://schemas.microsoft.com/office/drawing/2014/main" val="2400015112"/>
                    </a:ext>
                  </a:extLst>
                </a:gridCol>
                <a:gridCol w="856615">
                  <a:extLst>
                    <a:ext uri="{9D8B030D-6E8A-4147-A177-3AD203B41FA5}">
                      <a16:colId xmlns:a16="http://schemas.microsoft.com/office/drawing/2014/main" val="1051070153"/>
                    </a:ext>
                  </a:extLst>
                </a:gridCol>
                <a:gridCol w="623570">
                  <a:extLst>
                    <a:ext uri="{9D8B030D-6E8A-4147-A177-3AD203B41FA5}">
                      <a16:colId xmlns:a16="http://schemas.microsoft.com/office/drawing/2014/main" val="3654540362"/>
                    </a:ext>
                  </a:extLst>
                </a:gridCol>
                <a:gridCol w="1031240">
                  <a:extLst>
                    <a:ext uri="{9D8B030D-6E8A-4147-A177-3AD203B41FA5}">
                      <a16:colId xmlns:a16="http://schemas.microsoft.com/office/drawing/2014/main" val="3978748460"/>
                    </a:ext>
                  </a:extLst>
                </a:gridCol>
                <a:gridCol w="1054100">
                  <a:extLst>
                    <a:ext uri="{9D8B030D-6E8A-4147-A177-3AD203B41FA5}">
                      <a16:colId xmlns:a16="http://schemas.microsoft.com/office/drawing/2014/main" val="4167938369"/>
                    </a:ext>
                  </a:extLst>
                </a:gridCol>
              </a:tblGrid>
              <a:tr h="51943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200" kern="100" dirty="0">
                          <a:effectLst/>
                        </a:rPr>
                        <a:t>Haplogroups</a:t>
                      </a:r>
                      <a:endParaRPr lang="it-IT" sz="12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200" kern="100" dirty="0">
                          <a:effectLst/>
                        </a:rPr>
                        <a:t>CIPO (n)</a:t>
                      </a:r>
                      <a:endParaRPr lang="it-IT" sz="12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200" kern="100">
                          <a:effectLst/>
                        </a:rPr>
                        <a:t>Controls (n)</a:t>
                      </a:r>
                      <a:endParaRPr lang="it-IT" sz="12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200" kern="100">
                          <a:effectLst/>
                        </a:rPr>
                        <a:t>CIPO (%)</a:t>
                      </a:r>
                      <a:endParaRPr lang="it-IT" sz="12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200" kern="100">
                          <a:effectLst/>
                        </a:rPr>
                        <a:t>Controls (%)</a:t>
                      </a:r>
                      <a:endParaRPr lang="it-IT" sz="12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200" kern="100">
                          <a:effectLst/>
                        </a:rPr>
                        <a:t>P-value</a:t>
                      </a:r>
                      <a:endParaRPr lang="it-IT" sz="12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200" kern="100">
                          <a:effectLst/>
                        </a:rPr>
                        <a:t>Adjusted P-value</a:t>
                      </a:r>
                      <a:endParaRPr lang="it-IT" sz="12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200" kern="100">
                          <a:effectLst/>
                        </a:rPr>
                        <a:t>Odds Ratio (OR)</a:t>
                      </a:r>
                      <a:endParaRPr lang="it-IT" sz="12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469518672"/>
                  </a:ext>
                </a:extLst>
              </a:tr>
              <a:tr h="51943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200" kern="100">
                          <a:effectLst/>
                        </a:rPr>
                        <a:t>H</a:t>
                      </a:r>
                      <a:endParaRPr lang="it-IT" sz="12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200" kern="100" dirty="0">
                          <a:effectLst/>
                        </a:rPr>
                        <a:t>8</a:t>
                      </a:r>
                      <a:endParaRPr lang="it-IT" sz="12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200" kern="100" dirty="0">
                          <a:effectLst/>
                        </a:rPr>
                        <a:t>121</a:t>
                      </a:r>
                      <a:endParaRPr lang="it-IT" sz="12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200" kern="100" dirty="0">
                          <a:effectLst/>
                        </a:rPr>
                        <a:t>44%</a:t>
                      </a:r>
                      <a:endParaRPr lang="it-IT" sz="12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200" kern="100">
                          <a:effectLst/>
                        </a:rPr>
                        <a:t>37%</a:t>
                      </a:r>
                      <a:endParaRPr lang="it-IT" sz="12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200" kern="100">
                          <a:effectLst/>
                        </a:rPr>
                        <a:t>0.619</a:t>
                      </a:r>
                      <a:endParaRPr lang="it-IT" sz="12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200" kern="100">
                          <a:effectLst/>
                        </a:rPr>
                        <a:t>0.619</a:t>
                      </a:r>
                      <a:endParaRPr lang="it-IT" sz="12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200" kern="100">
                          <a:effectLst/>
                        </a:rPr>
                        <a:t>1.355</a:t>
                      </a:r>
                      <a:endParaRPr lang="it-IT" sz="12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80083527"/>
                  </a:ext>
                </a:extLst>
              </a:tr>
              <a:tr h="53213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200" kern="100">
                          <a:effectLst/>
                        </a:rPr>
                        <a:t>J</a:t>
                      </a:r>
                      <a:endParaRPr lang="it-IT" sz="12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200" kern="100">
                          <a:effectLst/>
                        </a:rPr>
                        <a:t>5</a:t>
                      </a:r>
                      <a:endParaRPr lang="it-IT" sz="12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200" kern="100" dirty="0">
                          <a:effectLst/>
                        </a:rPr>
                        <a:t>22</a:t>
                      </a:r>
                      <a:endParaRPr lang="it-IT" sz="12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200" kern="100">
                          <a:effectLst/>
                        </a:rPr>
                        <a:t>28%</a:t>
                      </a:r>
                      <a:endParaRPr lang="it-IT" sz="12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200" kern="100">
                          <a:effectLst/>
                        </a:rPr>
                        <a:t>7%</a:t>
                      </a:r>
                      <a:endParaRPr lang="it-IT" sz="12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200" kern="100">
                          <a:effectLst/>
                        </a:rPr>
                        <a:t>0.008</a:t>
                      </a:r>
                      <a:endParaRPr lang="it-IT" sz="12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200" kern="100">
                          <a:effectLst/>
                        </a:rPr>
                        <a:t>0.051</a:t>
                      </a:r>
                      <a:endParaRPr lang="it-IT" sz="12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200" kern="100">
                          <a:effectLst/>
                        </a:rPr>
                        <a:t>5.315</a:t>
                      </a:r>
                      <a:endParaRPr lang="it-IT" sz="12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491291232"/>
                  </a:ext>
                </a:extLst>
              </a:tr>
              <a:tr h="51943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200" kern="100">
                          <a:effectLst/>
                        </a:rPr>
                        <a:t>T</a:t>
                      </a:r>
                      <a:endParaRPr lang="it-IT" sz="12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200" kern="100">
                          <a:effectLst/>
                        </a:rPr>
                        <a:t>3</a:t>
                      </a:r>
                      <a:endParaRPr lang="it-IT" sz="12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200" kern="100">
                          <a:effectLst/>
                        </a:rPr>
                        <a:t>23</a:t>
                      </a:r>
                      <a:endParaRPr lang="it-IT" sz="12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200" kern="100" dirty="0">
                          <a:effectLst/>
                        </a:rPr>
                        <a:t>17%</a:t>
                      </a:r>
                      <a:endParaRPr lang="it-IT" sz="12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200" kern="100">
                          <a:effectLst/>
                        </a:rPr>
                        <a:t>7%</a:t>
                      </a:r>
                      <a:endParaRPr lang="it-IT" sz="12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200" kern="100">
                          <a:effectLst/>
                        </a:rPr>
                        <a:t>0.146</a:t>
                      </a:r>
                      <a:endParaRPr lang="it-IT" sz="12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200" kern="100">
                          <a:effectLst/>
                        </a:rPr>
                        <a:t>0.292</a:t>
                      </a:r>
                      <a:endParaRPr lang="it-IT" sz="12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200" kern="100">
                          <a:effectLst/>
                        </a:rPr>
                        <a:t>2.635</a:t>
                      </a:r>
                      <a:endParaRPr lang="it-IT" sz="12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462494440"/>
                  </a:ext>
                </a:extLst>
              </a:tr>
              <a:tr h="51943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200" kern="100">
                          <a:effectLst/>
                        </a:rPr>
                        <a:t>U</a:t>
                      </a:r>
                      <a:endParaRPr lang="it-IT" sz="12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200" kern="100">
                          <a:effectLst/>
                        </a:rPr>
                        <a:t>1</a:t>
                      </a:r>
                      <a:endParaRPr lang="it-IT" sz="12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200" kern="100">
                          <a:effectLst/>
                        </a:rPr>
                        <a:t>46</a:t>
                      </a:r>
                      <a:endParaRPr lang="it-IT" sz="12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200" kern="100" dirty="0">
                          <a:effectLst/>
                        </a:rPr>
                        <a:t>6%</a:t>
                      </a:r>
                      <a:endParaRPr lang="it-IT" sz="12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200" kern="100" dirty="0">
                          <a:effectLst/>
                        </a:rPr>
                        <a:t>14%</a:t>
                      </a:r>
                      <a:endParaRPr lang="it-IT" sz="12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200" kern="100">
                          <a:effectLst/>
                        </a:rPr>
                        <a:t>0.486</a:t>
                      </a:r>
                      <a:endParaRPr lang="it-IT" sz="12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200" kern="100">
                          <a:effectLst/>
                        </a:rPr>
                        <a:t>0.619</a:t>
                      </a:r>
                      <a:endParaRPr lang="it-IT" sz="12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200" kern="100">
                          <a:effectLst/>
                        </a:rPr>
                        <a:t>0.358</a:t>
                      </a:r>
                      <a:endParaRPr lang="it-IT" sz="12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214604421"/>
                  </a:ext>
                </a:extLst>
              </a:tr>
              <a:tr h="51943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200" kern="100">
                          <a:effectLst/>
                        </a:rPr>
                        <a:t>K</a:t>
                      </a:r>
                      <a:endParaRPr lang="it-IT" sz="12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200" kern="100">
                          <a:effectLst/>
                        </a:rPr>
                        <a:t>0</a:t>
                      </a:r>
                      <a:endParaRPr lang="it-IT" sz="12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200" kern="100">
                          <a:effectLst/>
                        </a:rPr>
                        <a:t>20</a:t>
                      </a:r>
                      <a:endParaRPr lang="it-IT" sz="12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200" kern="100">
                          <a:effectLst/>
                        </a:rPr>
                        <a:t>0%</a:t>
                      </a:r>
                      <a:endParaRPr lang="it-IT" sz="12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200" kern="100" dirty="0">
                          <a:effectLst/>
                        </a:rPr>
                        <a:t>6%</a:t>
                      </a:r>
                      <a:endParaRPr lang="it-IT" sz="12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200" kern="100" dirty="0">
                          <a:effectLst/>
                        </a:rPr>
                        <a:t>0.612</a:t>
                      </a:r>
                      <a:endParaRPr lang="it-IT" sz="12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200" kern="100">
                          <a:effectLst/>
                        </a:rPr>
                        <a:t>0.619</a:t>
                      </a:r>
                      <a:endParaRPr lang="it-IT" sz="12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200" kern="100">
                          <a:effectLst/>
                        </a:rPr>
                        <a:t>0.000</a:t>
                      </a:r>
                      <a:endParaRPr lang="it-IT" sz="12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545857518"/>
                  </a:ext>
                </a:extLst>
              </a:tr>
              <a:tr h="53213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200" kern="100">
                          <a:effectLst/>
                        </a:rPr>
                        <a:t>Others</a:t>
                      </a:r>
                      <a:endParaRPr lang="it-IT" sz="12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200" kern="100">
                          <a:effectLst/>
                        </a:rPr>
                        <a:t>1</a:t>
                      </a:r>
                      <a:endParaRPr lang="it-IT" sz="12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200" kern="100">
                          <a:effectLst/>
                        </a:rPr>
                        <a:t>94</a:t>
                      </a:r>
                      <a:endParaRPr lang="it-IT" sz="12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200" kern="100">
                          <a:effectLst/>
                        </a:rPr>
                        <a:t>6%</a:t>
                      </a:r>
                      <a:endParaRPr lang="it-IT" sz="12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200" kern="100">
                          <a:effectLst/>
                        </a:rPr>
                        <a:t>29%</a:t>
                      </a:r>
                      <a:endParaRPr lang="it-IT" sz="12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200" kern="100" dirty="0">
                          <a:effectLst/>
                        </a:rPr>
                        <a:t>0.030</a:t>
                      </a:r>
                      <a:endParaRPr lang="it-IT" sz="12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200" kern="100" dirty="0">
                          <a:effectLst/>
                        </a:rPr>
                        <a:t>0.091</a:t>
                      </a:r>
                      <a:endParaRPr lang="it-IT" sz="12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200" kern="100">
                          <a:effectLst/>
                        </a:rPr>
                        <a:t>0.145</a:t>
                      </a:r>
                      <a:endParaRPr lang="it-IT" sz="12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131588345"/>
                  </a:ext>
                </a:extLst>
              </a:tr>
              <a:tr h="51943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200" kern="100" dirty="0">
                          <a:effectLst/>
                        </a:rPr>
                        <a:t>Total</a:t>
                      </a:r>
                      <a:endParaRPr lang="it-IT" sz="12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200" kern="100">
                          <a:effectLst/>
                        </a:rPr>
                        <a:t>18</a:t>
                      </a:r>
                      <a:endParaRPr lang="it-IT" sz="12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200" kern="100">
                          <a:effectLst/>
                        </a:rPr>
                        <a:t>326</a:t>
                      </a:r>
                      <a:endParaRPr lang="it-IT" sz="12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200" kern="100">
                          <a:effectLst/>
                        </a:rPr>
                        <a:t>100%</a:t>
                      </a:r>
                      <a:endParaRPr lang="it-IT" sz="12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200" kern="100">
                          <a:effectLst/>
                        </a:rPr>
                        <a:t>100%</a:t>
                      </a:r>
                      <a:endParaRPr lang="it-IT" sz="12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200" kern="100">
                          <a:effectLst/>
                        </a:rPr>
                        <a:t> </a:t>
                      </a:r>
                      <a:endParaRPr lang="it-IT" sz="12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200" kern="100" dirty="0">
                          <a:effectLst/>
                        </a:rPr>
                        <a:t> </a:t>
                      </a:r>
                      <a:endParaRPr lang="it-IT" sz="12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200" kern="100" dirty="0">
                          <a:effectLst/>
                        </a:rPr>
                        <a:t> </a:t>
                      </a:r>
                      <a:endParaRPr lang="it-IT" sz="12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740991112"/>
                  </a:ext>
                </a:extLst>
              </a:tr>
            </a:tbl>
          </a:graphicData>
        </a:graphic>
      </p:graphicFrame>
      <p:sp>
        <p:nvSpPr>
          <p:cNvPr id="5" name="Rettangolo 4">
            <a:extLst>
              <a:ext uri="{FF2B5EF4-FFF2-40B4-BE49-F238E27FC236}">
                <a16:creationId xmlns:a16="http://schemas.microsoft.com/office/drawing/2014/main" id="{FF54F3AB-4933-45DE-AA97-6565D4598780}"/>
              </a:ext>
            </a:extLst>
          </p:cNvPr>
          <p:cNvSpPr/>
          <p:nvPr/>
        </p:nvSpPr>
        <p:spPr>
          <a:xfrm>
            <a:off x="1890318" y="1160569"/>
            <a:ext cx="7354349" cy="40902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indent="449580">
              <a:lnSpc>
                <a:spcPct val="200000"/>
              </a:lnSpc>
              <a:spcAft>
                <a:spcPts val="1000"/>
              </a:spcAft>
            </a:pP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Table 2.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itochondrial haplogroups distribution.</a:t>
            </a:r>
            <a:endParaRPr lang="it-IT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51188665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9</Words>
  <Application>Microsoft Office PowerPoint</Application>
  <PresentationFormat>Widescreen</PresentationFormat>
  <Paragraphs>65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i Office</vt:lpstr>
      <vt:lpstr>Presentazione standard di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Elisa Boschetti</dc:creator>
  <cp:lastModifiedBy>Elisa Boschetti</cp:lastModifiedBy>
  <cp:revision>1</cp:revision>
  <dcterms:created xsi:type="dcterms:W3CDTF">2025-03-21T14:32:12Z</dcterms:created>
  <dcterms:modified xsi:type="dcterms:W3CDTF">2026-02-12T10:29:58Z</dcterms:modified>
</cp:coreProperties>
</file>